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72"/>
    <p:restoredTop sz="94643"/>
  </p:normalViewPr>
  <p:slideViewPr>
    <p:cSldViewPr snapToGrid="0" snapToObjects="1">
      <p:cViewPr varScale="1">
        <p:scale>
          <a:sx n="109" d="100"/>
          <a:sy n="109" d="100"/>
        </p:scale>
        <p:origin x="-1152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A5C00-4F6A-3848-B428-DB4CD4362C73}" type="datetimeFigureOut">
              <a:rPr lang="en-US" smtClean="0"/>
              <a:t>17-12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27F21-2490-5946-B89F-B2E3EF0D0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890690" y="499992"/>
            <a:ext cx="7358950" cy="5785504"/>
            <a:chOff x="890690" y="499992"/>
            <a:chExt cx="7358950" cy="5785504"/>
          </a:xfrm>
        </p:grpSpPr>
        <p:grpSp>
          <p:nvGrpSpPr>
            <p:cNvPr id="12" name="Group 11"/>
            <p:cNvGrpSpPr/>
            <p:nvPr/>
          </p:nvGrpSpPr>
          <p:grpSpPr>
            <a:xfrm>
              <a:off x="909185" y="3429000"/>
              <a:ext cx="7340455" cy="2856496"/>
              <a:chOff x="897534" y="569898"/>
              <a:chExt cx="7340455" cy="2856496"/>
            </a:xfrm>
          </p:grpSpPr>
          <p:pic>
            <p:nvPicPr>
              <p:cNvPr id="3" name="Picture 2"/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231"/>
              <a:stretch/>
            </p:blipFill>
            <p:spPr>
              <a:xfrm>
                <a:off x="1181990" y="939550"/>
                <a:ext cx="7055999" cy="2486844"/>
              </a:xfrm>
              <a:prstGeom prst="rect">
                <a:avLst/>
              </a:prstGeom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920388" y="569898"/>
                <a:ext cx="35573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latin typeface="Arial"/>
                    <a:cs typeface="Arial"/>
                  </a:rPr>
                  <a:t>B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 rot="16200000">
                <a:off x="287006" y="1489322"/>
                <a:ext cx="168272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/>
                    <a:cs typeface="Arial"/>
                  </a:rPr>
                  <a:t>Affymetrix</a:t>
                </a:r>
                <a:r>
                  <a:rPr lang="en-US" sz="1200" dirty="0" smtClean="0">
                    <a:latin typeface="Arial"/>
                    <a:cs typeface="Arial"/>
                  </a:rPr>
                  <a:t> Expression</a:t>
                </a:r>
              </a:p>
              <a:p>
                <a:pPr algn="ctr"/>
                <a:r>
                  <a:rPr lang="en-US" sz="1200" dirty="0" smtClean="0">
                    <a:latin typeface="Arial"/>
                    <a:cs typeface="Arial"/>
                  </a:rPr>
                  <a:t>Arbitrary unit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890690" y="499992"/>
              <a:ext cx="7348932" cy="2506230"/>
              <a:chOff x="897534" y="3426394"/>
              <a:chExt cx="7348932" cy="2506230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2"/>
              <a:stretch/>
            </p:blipFill>
            <p:spPr>
              <a:xfrm>
                <a:off x="1359200" y="3705059"/>
                <a:ext cx="6887266" cy="2227565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920388" y="3426394"/>
                <a:ext cx="37702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latin typeface="Arial"/>
                    <a:cs typeface="Arial"/>
                  </a:rPr>
                  <a:t>A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6200000">
                <a:off x="287006" y="4345819"/>
                <a:ext cx="168272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/>
                    <a:cs typeface="Arial"/>
                  </a:rPr>
                  <a:t>Affymetrix</a:t>
                </a:r>
                <a:r>
                  <a:rPr lang="en-US" sz="1200" dirty="0" smtClean="0">
                    <a:latin typeface="Arial"/>
                    <a:cs typeface="Arial"/>
                  </a:rPr>
                  <a:t> Expression</a:t>
                </a:r>
              </a:p>
              <a:p>
                <a:pPr algn="ctr"/>
                <a:r>
                  <a:rPr lang="en-US" sz="1200" dirty="0" smtClean="0">
                    <a:latin typeface="Arial"/>
                    <a:cs typeface="Arial"/>
                  </a:rPr>
                  <a:t>Arbitrary units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</p:grpSp>
      </p:grpSp>
      <p:sp>
        <p:nvSpPr>
          <p:cNvPr id="9" name="TextBox 8"/>
          <p:cNvSpPr txBox="1"/>
          <p:nvPr/>
        </p:nvSpPr>
        <p:spPr>
          <a:xfrm>
            <a:off x="6545757" y="6543094"/>
            <a:ext cx="2558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Annis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, Additional File: Fig. S1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0312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</TotalTime>
  <Words>21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G Annis, Dr</dc:creator>
  <cp:lastModifiedBy>Peter Siegel</cp:lastModifiedBy>
  <cp:revision>9</cp:revision>
  <dcterms:created xsi:type="dcterms:W3CDTF">2017-11-10T16:45:01Z</dcterms:created>
  <dcterms:modified xsi:type="dcterms:W3CDTF">2017-12-17T14:15:16Z</dcterms:modified>
</cp:coreProperties>
</file>